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358" r:id="rId5"/>
  </p:sldIdLst>
  <p:sldSz cx="6218238" cy="82296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E5FC"/>
    <a:srgbClr val="DCB9FF"/>
    <a:srgbClr val="009999"/>
    <a:srgbClr val="C100C1"/>
    <a:srgbClr val="FF3399"/>
    <a:srgbClr val="E80E7B"/>
    <a:srgbClr val="E1F0EE"/>
    <a:srgbClr val="FCC8F0"/>
    <a:srgbClr val="F5C71D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6" autoAdjust="0"/>
    <p:restoredTop sz="96807" autoAdjust="0"/>
  </p:normalViewPr>
  <p:slideViewPr>
    <p:cSldViewPr snapToGrid="0">
      <p:cViewPr>
        <p:scale>
          <a:sx n="53" d="100"/>
          <a:sy n="53" d="100"/>
        </p:scale>
        <p:origin x="2155" y="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6369" y="1346836"/>
            <a:ext cx="5285502" cy="2865120"/>
          </a:xfrm>
        </p:spPr>
        <p:txBody>
          <a:bodyPr anchor="b"/>
          <a:lstStyle>
            <a:lvl1pPr algn="ctr"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7280" y="4322446"/>
            <a:ext cx="4663679" cy="1986914"/>
          </a:xfrm>
        </p:spPr>
        <p:txBody>
          <a:bodyPr/>
          <a:lstStyle>
            <a:lvl1pPr marL="0" indent="0" algn="ctr">
              <a:buNone/>
              <a:defRPr sz="1632"/>
            </a:lvl1pPr>
            <a:lvl2pPr marL="310896" indent="0" algn="ctr">
              <a:buNone/>
              <a:defRPr sz="1360"/>
            </a:lvl2pPr>
            <a:lvl3pPr marL="621792" indent="0" algn="ctr">
              <a:buNone/>
              <a:defRPr sz="1224"/>
            </a:lvl3pPr>
            <a:lvl4pPr marL="932688" indent="0" algn="ctr">
              <a:buNone/>
              <a:defRPr sz="1088"/>
            </a:lvl4pPr>
            <a:lvl5pPr marL="1243584" indent="0" algn="ctr">
              <a:buNone/>
              <a:defRPr sz="1088"/>
            </a:lvl5pPr>
            <a:lvl6pPr marL="1554480" indent="0" algn="ctr">
              <a:buNone/>
              <a:defRPr sz="1088"/>
            </a:lvl6pPr>
            <a:lvl7pPr marL="1865376" indent="0" algn="ctr">
              <a:buNone/>
              <a:defRPr sz="1088"/>
            </a:lvl7pPr>
            <a:lvl8pPr marL="2176272" indent="0" algn="ctr">
              <a:buNone/>
              <a:defRPr sz="1088"/>
            </a:lvl8pPr>
            <a:lvl9pPr marL="2487168" indent="0" algn="ctr">
              <a:buNone/>
              <a:defRPr sz="108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596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4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49927" y="438150"/>
            <a:ext cx="134080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504" y="438150"/>
            <a:ext cx="3944696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65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67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266" y="2051688"/>
            <a:ext cx="5363231" cy="3423284"/>
          </a:xfrm>
        </p:spPr>
        <p:txBody>
          <a:bodyPr anchor="b"/>
          <a:lstStyle>
            <a:lvl1pPr>
              <a:defRPr sz="40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266" y="5507358"/>
            <a:ext cx="5363231" cy="1800224"/>
          </a:xfrm>
        </p:spPr>
        <p:txBody>
          <a:bodyPr/>
          <a:lstStyle>
            <a:lvl1pPr marL="0" indent="0">
              <a:buNone/>
              <a:defRPr sz="1632">
                <a:solidFill>
                  <a:schemeClr val="tx1"/>
                </a:solidFill>
              </a:defRPr>
            </a:lvl1pPr>
            <a:lvl2pPr marL="31089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2pPr>
            <a:lvl3pPr marL="621792" indent="0">
              <a:buNone/>
              <a:defRPr sz="1224">
                <a:solidFill>
                  <a:schemeClr val="tx1">
                    <a:tint val="75000"/>
                  </a:schemeClr>
                </a:solidFill>
              </a:defRPr>
            </a:lvl3pPr>
            <a:lvl4pPr marL="93268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4pPr>
            <a:lvl5pPr marL="1243584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5pPr>
            <a:lvl6pPr marL="1554480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6pPr>
            <a:lvl7pPr marL="1865376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7pPr>
            <a:lvl8pPr marL="2176272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8pPr>
            <a:lvl9pPr marL="2487168" indent="0">
              <a:buNone/>
              <a:defRPr sz="10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34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505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7984" y="2190750"/>
            <a:ext cx="26427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42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4" y="438152"/>
            <a:ext cx="5363231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315" y="2017396"/>
            <a:ext cx="2630605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315" y="3006090"/>
            <a:ext cx="263060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47985" y="2017396"/>
            <a:ext cx="2643561" cy="988694"/>
          </a:xfrm>
        </p:spPr>
        <p:txBody>
          <a:bodyPr anchor="b"/>
          <a:lstStyle>
            <a:lvl1pPr marL="0" indent="0">
              <a:buNone/>
              <a:defRPr sz="1632" b="1"/>
            </a:lvl1pPr>
            <a:lvl2pPr marL="310896" indent="0">
              <a:buNone/>
              <a:defRPr sz="1360" b="1"/>
            </a:lvl2pPr>
            <a:lvl3pPr marL="621792" indent="0">
              <a:buNone/>
              <a:defRPr sz="1224" b="1"/>
            </a:lvl3pPr>
            <a:lvl4pPr marL="932688" indent="0">
              <a:buNone/>
              <a:defRPr sz="1088" b="1"/>
            </a:lvl4pPr>
            <a:lvl5pPr marL="1243584" indent="0">
              <a:buNone/>
              <a:defRPr sz="1088" b="1"/>
            </a:lvl5pPr>
            <a:lvl6pPr marL="1554480" indent="0">
              <a:buNone/>
              <a:defRPr sz="1088" b="1"/>
            </a:lvl6pPr>
            <a:lvl7pPr marL="1865376" indent="0">
              <a:buNone/>
              <a:defRPr sz="1088" b="1"/>
            </a:lvl7pPr>
            <a:lvl8pPr marL="2176272" indent="0">
              <a:buNone/>
              <a:defRPr sz="1088" b="1"/>
            </a:lvl8pPr>
            <a:lvl9pPr marL="2487168" indent="0">
              <a:buNone/>
              <a:defRPr sz="108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47985" y="3006090"/>
            <a:ext cx="26435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00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2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58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3562" y="1184912"/>
            <a:ext cx="3147982" cy="5848350"/>
          </a:xfrm>
        </p:spPr>
        <p:txBody>
          <a:bodyPr/>
          <a:lstStyle>
            <a:lvl1pPr>
              <a:defRPr sz="2176"/>
            </a:lvl1pPr>
            <a:lvl2pPr>
              <a:defRPr sz="1904"/>
            </a:lvl2pPr>
            <a:lvl3pPr>
              <a:defRPr sz="1632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90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315" y="548640"/>
            <a:ext cx="2005543" cy="1920240"/>
          </a:xfrm>
        </p:spPr>
        <p:txBody>
          <a:bodyPr anchor="b"/>
          <a:lstStyle>
            <a:lvl1pPr>
              <a:defRPr sz="21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3562" y="1184912"/>
            <a:ext cx="3147982" cy="5848350"/>
          </a:xfrm>
        </p:spPr>
        <p:txBody>
          <a:bodyPr anchor="t"/>
          <a:lstStyle>
            <a:lvl1pPr marL="0" indent="0">
              <a:buNone/>
              <a:defRPr sz="2176"/>
            </a:lvl1pPr>
            <a:lvl2pPr marL="310896" indent="0">
              <a:buNone/>
              <a:defRPr sz="1904"/>
            </a:lvl2pPr>
            <a:lvl3pPr marL="621792" indent="0">
              <a:buNone/>
              <a:defRPr sz="1632"/>
            </a:lvl3pPr>
            <a:lvl4pPr marL="932688" indent="0">
              <a:buNone/>
              <a:defRPr sz="1360"/>
            </a:lvl4pPr>
            <a:lvl5pPr marL="1243584" indent="0">
              <a:buNone/>
              <a:defRPr sz="1360"/>
            </a:lvl5pPr>
            <a:lvl6pPr marL="1554480" indent="0">
              <a:buNone/>
              <a:defRPr sz="1360"/>
            </a:lvl6pPr>
            <a:lvl7pPr marL="1865376" indent="0">
              <a:buNone/>
              <a:defRPr sz="1360"/>
            </a:lvl7pPr>
            <a:lvl8pPr marL="2176272" indent="0">
              <a:buNone/>
              <a:defRPr sz="1360"/>
            </a:lvl8pPr>
            <a:lvl9pPr marL="2487168" indent="0">
              <a:buNone/>
              <a:defRPr sz="13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315" y="2468880"/>
            <a:ext cx="2005543" cy="4573906"/>
          </a:xfrm>
        </p:spPr>
        <p:txBody>
          <a:bodyPr/>
          <a:lstStyle>
            <a:lvl1pPr marL="0" indent="0">
              <a:buNone/>
              <a:defRPr sz="1088"/>
            </a:lvl1pPr>
            <a:lvl2pPr marL="310896" indent="0">
              <a:buNone/>
              <a:defRPr sz="952"/>
            </a:lvl2pPr>
            <a:lvl3pPr marL="621792" indent="0">
              <a:buNone/>
              <a:defRPr sz="816"/>
            </a:lvl3pPr>
            <a:lvl4pPr marL="932688" indent="0">
              <a:buNone/>
              <a:defRPr sz="680"/>
            </a:lvl4pPr>
            <a:lvl5pPr marL="1243584" indent="0">
              <a:buNone/>
              <a:defRPr sz="680"/>
            </a:lvl5pPr>
            <a:lvl6pPr marL="1554480" indent="0">
              <a:buNone/>
              <a:defRPr sz="680"/>
            </a:lvl6pPr>
            <a:lvl7pPr marL="1865376" indent="0">
              <a:buNone/>
              <a:defRPr sz="680"/>
            </a:lvl7pPr>
            <a:lvl8pPr marL="2176272" indent="0">
              <a:buNone/>
              <a:defRPr sz="680"/>
            </a:lvl8pPr>
            <a:lvl9pPr marL="2487168" indent="0">
              <a:buNone/>
              <a:defRPr sz="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86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7504" y="438152"/>
            <a:ext cx="5363231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504" y="2190750"/>
            <a:ext cx="5363231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7503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51D29-AF93-4167-B159-41ADEA99694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9794" y="7627622"/>
            <a:ext cx="209865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1631" y="7627622"/>
            <a:ext cx="1399104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A4433-82E0-4CE0-8303-73218E51B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34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1792" rtl="0" eaLnBrk="1" latinLnBrk="0" hangingPunct="1">
        <a:lnSpc>
          <a:spcPct val="90000"/>
        </a:lnSpc>
        <a:spcBef>
          <a:spcPct val="0"/>
        </a:spcBef>
        <a:buNone/>
        <a:defRPr sz="29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448" indent="-155448" algn="l" defTabSz="621792" rtl="0" eaLnBrk="1" latinLnBrk="0" hangingPunct="1">
        <a:lnSpc>
          <a:spcPct val="90000"/>
        </a:lnSpc>
        <a:spcBef>
          <a:spcPts val="680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1pPr>
      <a:lvl2pPr marL="46634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2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60" kern="1200">
          <a:solidFill>
            <a:schemeClr val="tx1"/>
          </a:solidFill>
          <a:latin typeface="+mn-lt"/>
          <a:ea typeface="+mn-ea"/>
          <a:cs typeface="+mn-cs"/>
        </a:defRPr>
      </a:lvl3pPr>
      <a:lvl4pPr marL="108813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399032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709928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2020824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331720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642616" indent="-155448" algn="l" defTabSz="621792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1pPr>
      <a:lvl2pPr marL="31089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2pPr>
      <a:lvl3pPr marL="62179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3pPr>
      <a:lvl4pPr marL="93268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4pPr>
      <a:lvl5pPr marL="1243584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5pPr>
      <a:lvl6pPr marL="1554480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6pPr>
      <a:lvl7pPr marL="1865376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7pPr>
      <a:lvl8pPr marL="2176272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8pPr>
      <a:lvl9pPr marL="2487168" algn="l" defTabSz="621792" rtl="0" eaLnBrk="1" latinLnBrk="0" hangingPunct="1">
        <a:defRPr sz="12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90CD7A9-45BE-242A-686A-A2D45F2C4D24}"/>
              </a:ext>
            </a:extLst>
          </p:cNvPr>
          <p:cNvSpPr txBox="1"/>
          <p:nvPr/>
        </p:nvSpPr>
        <p:spPr>
          <a:xfrm>
            <a:off x="434473" y="837802"/>
            <a:ext cx="4977968" cy="2204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4D</a:t>
            </a:r>
          </a:p>
          <a:p>
            <a:pPr>
              <a:lnSpc>
                <a:spcPct val="150000"/>
              </a:lnSpc>
            </a:pP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altered versions of the immunoblots presented in Figure 4D are shown. The red-boxed area was cropped, inverted, and color-corrected using PowerPoint to generate Figure 4D. The uncropped, inverted, and color-corrected versions of full lane immunoblots are provided in Appendix Figure S4.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EA184B1C-501C-AA91-AEE4-FDFA32E7E4A4}"/>
              </a:ext>
            </a:extLst>
          </p:cNvPr>
          <p:cNvGrpSpPr/>
          <p:nvPr/>
        </p:nvGrpSpPr>
        <p:grpSpPr>
          <a:xfrm>
            <a:off x="309328" y="3900923"/>
            <a:ext cx="2596923" cy="2944352"/>
            <a:chOff x="919350" y="236123"/>
            <a:chExt cx="3462564" cy="3925803"/>
          </a:xfrm>
        </p:grpSpPr>
        <p:pic>
          <p:nvPicPr>
            <p:cNvPr id="5" name="Picture 4" descr="A blue paper with writing on it&#10;&#10;Description automatically generated">
              <a:extLst>
                <a:ext uri="{FF2B5EF4-FFF2-40B4-BE49-F238E27FC236}">
                  <a16:creationId xmlns:a16="http://schemas.microsoft.com/office/drawing/2014/main" id="{D79C6248-9C16-6F1D-A4C5-1E71CE21065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9350" y="236123"/>
              <a:ext cx="3462564" cy="3925803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CFFF8EE2-5BAB-F803-0CD5-4658D8EB7848}"/>
                </a:ext>
              </a:extLst>
            </p:cNvPr>
            <p:cNvSpPr/>
            <p:nvPr/>
          </p:nvSpPr>
          <p:spPr>
            <a:xfrm>
              <a:off x="3242474" y="813423"/>
              <a:ext cx="547226" cy="155952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34670F2A-3BDD-21EC-E973-ACDABB8E8D92}"/>
              </a:ext>
            </a:extLst>
          </p:cNvPr>
          <p:cNvSpPr txBox="1"/>
          <p:nvPr/>
        </p:nvSpPr>
        <p:spPr>
          <a:xfrm rot="5400000">
            <a:off x="1473671" y="6553362"/>
            <a:ext cx="400110" cy="98393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mCherry</a:t>
            </a:r>
            <a:endParaRPr 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0D123E8B-9EF6-8F8C-E2E0-C270E3CF4C71}"/>
              </a:ext>
            </a:extLst>
          </p:cNvPr>
          <p:cNvGrpSpPr>
            <a:grpSpLocks noChangeAspect="1"/>
          </p:cNvGrpSpPr>
          <p:nvPr/>
        </p:nvGrpSpPr>
        <p:grpSpPr>
          <a:xfrm>
            <a:off x="3207680" y="4058166"/>
            <a:ext cx="2701230" cy="2787109"/>
            <a:chOff x="791728" y="4414854"/>
            <a:chExt cx="3601640" cy="3716145"/>
          </a:xfrm>
        </p:grpSpPr>
        <p:pic>
          <p:nvPicPr>
            <p:cNvPr id="7" name="Picture 6" descr="A close-up of a test&#10;&#10;Description automatically generated">
              <a:extLst>
                <a:ext uri="{FF2B5EF4-FFF2-40B4-BE49-F238E27FC236}">
                  <a16:creationId xmlns:a16="http://schemas.microsoft.com/office/drawing/2014/main" id="{D8C25335-77A9-6257-1872-E91D3112A5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1728" y="4414854"/>
              <a:ext cx="3601640" cy="3716145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553F3771-13A8-B3D8-8EB4-AB509A89B635}"/>
                </a:ext>
              </a:extLst>
            </p:cNvPr>
            <p:cNvSpPr/>
            <p:nvPr/>
          </p:nvSpPr>
          <p:spPr>
            <a:xfrm>
              <a:off x="3216021" y="5082099"/>
              <a:ext cx="547226" cy="13467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A8BEC268-12D7-DBAE-68B1-6840DCC43AEA}"/>
              </a:ext>
            </a:extLst>
          </p:cNvPr>
          <p:cNvSpPr txBox="1"/>
          <p:nvPr/>
        </p:nvSpPr>
        <p:spPr>
          <a:xfrm rot="5400000">
            <a:off x="4195270" y="6563352"/>
            <a:ext cx="400110" cy="11004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aldolase</a:t>
            </a:r>
            <a:endParaRPr 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0696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87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2CA10241-3744-402C-BB55-0CCC07CA7F38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6962610C67D4B49A88B6FAB491E3AE5" ma:contentTypeVersion="14" ma:contentTypeDescription="Create a new document." ma:contentTypeScope="" ma:versionID="bdab3a0ad6a9855bfbdcd6b489fe3c69">
  <xsd:schema xmlns:xsd="http://www.w3.org/2001/XMLSchema" xmlns:xs="http://www.w3.org/2001/XMLSchema" xmlns:p="http://schemas.microsoft.com/office/2006/metadata/properties" xmlns:ns3="18272914-71e0-42fc-9685-7c3d7493b947" xmlns:ns4="1ada6c1b-6627-4503-b0bd-5fd9b9908e29" targetNamespace="http://schemas.microsoft.com/office/2006/metadata/properties" ma:root="true" ma:fieldsID="63200ee40b5c47ed65451d97f7303378" ns3:_="" ns4:_="">
    <xsd:import namespace="18272914-71e0-42fc-9685-7c3d7493b947"/>
    <xsd:import namespace="1ada6c1b-6627-4503-b0bd-5fd9b9908e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ObjectDetectorVersions" minOccurs="0"/>
                <xsd:element ref="ns3:_activity" minOccurs="0"/>
                <xsd:element ref="ns3:MediaServiceSearchProperties" minOccurs="0"/>
                <xsd:element ref="ns3:MediaServiceSystem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272914-71e0-42fc-9685-7c3d7493b94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18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da6c1b-6627-4503-b0bd-5fd9b9908e2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8272914-71e0-42fc-9685-7c3d7493b947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7E71F50-D89D-49F9-A239-1B8EDA19636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8272914-71e0-42fc-9685-7c3d7493b947"/>
    <ds:schemaRef ds:uri="1ada6c1b-6627-4503-b0bd-5fd9b9908e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A90B254-CE57-4786-8434-001DC6CED1BB}">
  <ds:schemaRefs>
    <ds:schemaRef ds:uri="http://schemas.microsoft.com/office/infopath/2007/PartnerControls"/>
    <ds:schemaRef ds:uri="http://schemas.microsoft.com/office/2006/metadata/properties"/>
    <ds:schemaRef ds:uri="http://purl.org/dc/dcmitype/"/>
    <ds:schemaRef ds:uri="http://schemas.openxmlformats.org/package/2006/metadata/core-properties"/>
    <ds:schemaRef ds:uri="http://purl.org/dc/terms/"/>
    <ds:schemaRef ds:uri="18272914-71e0-42fc-9685-7c3d7493b947"/>
    <ds:schemaRef ds:uri="http://www.w3.org/XML/1998/namespace"/>
    <ds:schemaRef ds:uri="http://schemas.microsoft.com/office/2006/documentManagement/types"/>
    <ds:schemaRef ds:uri="1ada6c1b-6627-4503-b0bd-5fd9b9908e29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9D5C7AA1-25AA-4EAE-B43E-6AED5957082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528</TotalTime>
  <Words>57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bayet Elahi</dc:creator>
  <cp:lastModifiedBy>Rubayet Elahi</cp:lastModifiedBy>
  <cp:revision>1007</cp:revision>
  <cp:lastPrinted>2025-01-06T02:27:25Z</cp:lastPrinted>
  <dcterms:created xsi:type="dcterms:W3CDTF">2020-01-28T22:13:46Z</dcterms:created>
  <dcterms:modified xsi:type="dcterms:W3CDTF">2025-01-06T21:07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6962610C67D4B49A88B6FAB491E3AE5</vt:lpwstr>
  </property>
</Properties>
</file>